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95" r:id="rId2"/>
  </p:sldIdLst>
  <p:sldSz cx="12192000" cy="6858000"/>
  <p:notesSz cx="6858000" cy="9144000"/>
  <p:defaultTextStyle>
    <a:defPPr>
      <a:defRPr lang="en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7FD"/>
    <a:srgbClr val="00F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52"/>
    <p:restoredTop sz="96024"/>
  </p:normalViewPr>
  <p:slideViewPr>
    <p:cSldViewPr snapToGrid="0">
      <p:cViewPr varScale="1">
        <p:scale>
          <a:sx n="118" d="100"/>
          <a:sy n="118" d="100"/>
        </p:scale>
        <p:origin x="2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CAD3D6-37C9-4147-B278-1963F1536092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Z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AECB52-E978-A544-96DD-6FD31120623B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28718188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3F4654-C192-3E5A-34A0-847B6AF145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84A4200-C507-5388-3EED-15B65F37B7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C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009E49-089D-6348-D1E0-AE687E660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E26E5B-D066-4265-939C-CA937BB025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C1594C-1115-A491-2ABF-758DA104E5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31584682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A751AC-5564-9E42-4810-DA4F205E1E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BE283B-FE30-3E17-B0BE-53F8DD9586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E8605A-C54A-3F0B-B5C5-44C8F8FF4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0FE680-AA6D-F3AB-7C24-54188B6D0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531BB9-54CF-0921-8F48-A25FDC775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12127542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7D5C938-A833-F1E6-5681-006F7AAF05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5D98C3-DC75-C9C4-E8A5-17305E6E5E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87EFBD-5F93-4C44-A1B5-1C5DD440A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0E6F75-8EC3-B87A-207C-2C1CF9A61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88A6E5-3F16-C199-B953-0342F7BC9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1946736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6DC1D3-9131-F662-3D71-8C082C309B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D2FFB8-7AE1-B4AD-6616-39D52BBD22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6DB8E0-75B5-0CBA-2966-88C217D1F7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63366D-5B29-924C-D21A-5AE68BDB2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329F3D-8B61-ABFE-7883-EA810954F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2407436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5FE72E-77F5-DA38-3796-84D067EE3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AF3846-42B5-9DB0-0863-DC7EE8FFD6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C12A3E-0DBC-0874-7FD5-8D474E3B8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9FAC45-129B-B82B-5323-AD717733D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96E49D-7651-459B-4E1A-3840B2343B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1879588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142577-9279-5FF6-A70C-49E809DD55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1F3CB5-B57C-EB48-5726-F1C222D995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865EC0-7121-EF59-C613-E799A48756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1323A9-E2E4-14BE-FCF3-7FA2D4762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6EBBAC-9ADF-BA3E-DFA2-EECA5F5327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C12AB1-56FB-67A0-BE0D-3FDA43230C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2925876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72CD81-92EE-58AD-9257-83820FF468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ED8D19-4CC3-C105-6128-C5FE21F60D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96698D-59F7-9343-8B7F-ACDCD8BE9A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6AC3A53-C66A-E1C0-7B36-E0401F905A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7BF2589-302B-E985-3265-A1B2313AFA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F918DE-5AC7-E1ED-A193-DCAF62903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A8ACA39-DC34-CC91-5830-21C642D93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7D6AAA9-403E-F600-F0A3-178802A60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3058759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79A423-3057-F9EC-578A-EAB414D069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0E97B78-E5D5-B120-AD98-8182972BF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6725A7F-D4B8-F81C-62F9-0DE76BEC0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FED6F08-8488-CF2A-936C-4C0CEEBB5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3296098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4478F94-27F4-3953-8CF2-66E314587B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8EECA4E-B81E-DB7C-0608-91F966C4C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81C13B2-3D05-7231-A67A-AF04A97E7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2240202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8D85E7-93E0-86A9-DDBC-452F73BE7F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97862E-49F4-5327-BA5B-558D769761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0B2A20-D921-307C-A595-1B16575F3C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2A9B4F-19E8-28FA-4894-E249B2E33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F73396-BB9E-04B6-2469-2C685436CF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81FEB3-0793-19E8-4C96-9B37BD0796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674125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B16F8B-F2D8-A01F-C275-22B952260F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629D27E-81CF-906F-4254-F8FF618743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D7D982-02FA-90F8-3E0C-31C94EDC8B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93CD02-AF26-BCE7-E60A-3D3BD1250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F68123-ECC3-DC36-91AF-9C255EB86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AE9D73-6EBD-2718-93DD-F49BE221D7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2736684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06BE48F-CE37-B63B-2342-D2C2412AF5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E6AC44-1002-1C94-3F8E-07AEBB95B2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596984-5C02-F1BB-5E09-ECE362BACE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9E1266-C246-5C59-CF42-043A7B9AA3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4C6180-D34B-57F3-445F-5FA806205F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2013282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microsoft.com/office/2007/relationships/media" Target="../media/media2.avi"/><Relationship Id="rId7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5" Type="http://schemas.microsoft.com/office/2007/relationships/media" Target="../media/media3.avi"/><Relationship Id="rId10" Type="http://schemas.openxmlformats.org/officeDocument/2006/relationships/image" Target="../media/image3.png"/><Relationship Id="rId4" Type="http://schemas.openxmlformats.org/officeDocument/2006/relationships/video" Target="../media/media2.avi"/><Relationship Id="rId9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6.nd2 - C=0">
            <a:hlinkClick r:id="" action="ppaction://media"/>
            <a:extLst>
              <a:ext uri="{FF2B5EF4-FFF2-40B4-BE49-F238E27FC236}">
                <a16:creationId xmlns:a16="http://schemas.microsoft.com/office/drawing/2014/main" id="{EBDC4632-8B88-2D86-D758-4768C504C38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2905170" y="3840117"/>
            <a:ext cx="3710152" cy="1218050"/>
          </a:xfrm>
          <a:prstGeom prst="rect">
            <a:avLst/>
          </a:prstGeom>
        </p:spPr>
      </p:pic>
      <p:pic>
        <p:nvPicPr>
          <p:cNvPr id="4" name="6.nd2 - C=0">
            <a:hlinkClick r:id="" action="ppaction://media"/>
            <a:extLst>
              <a:ext uri="{FF2B5EF4-FFF2-40B4-BE49-F238E27FC236}">
                <a16:creationId xmlns:a16="http://schemas.microsoft.com/office/drawing/2014/main" id="{EDFB9358-CAE4-F76D-B09E-A8441086A908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2905170" y="2583228"/>
            <a:ext cx="3710152" cy="1218050"/>
          </a:xfrm>
          <a:prstGeom prst="rect">
            <a:avLst/>
          </a:prstGeom>
        </p:spPr>
      </p:pic>
      <p:pic>
        <p:nvPicPr>
          <p:cNvPr id="6" name="8.nd2 - C=0">
            <a:hlinkClick r:id="" action="ppaction://media"/>
            <a:extLst>
              <a:ext uri="{FF2B5EF4-FFF2-40B4-BE49-F238E27FC236}">
                <a16:creationId xmlns:a16="http://schemas.microsoft.com/office/drawing/2014/main" id="{11A4725F-8367-E547-1B27-7BB5F6398B6D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2905170" y="1583834"/>
            <a:ext cx="3710152" cy="95203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56210A6-2889-1BBA-29CA-2BA05BD3118E}"/>
              </a:ext>
            </a:extLst>
          </p:cNvPr>
          <p:cNvSpPr txBox="1"/>
          <p:nvPr/>
        </p:nvSpPr>
        <p:spPr>
          <a:xfrm>
            <a:off x="1127640" y="1848228"/>
            <a:ext cx="1875835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Z" sz="2400" b="1" dirty="0">
                <a:latin typeface="Arial" panose="020B0604020202020204" pitchFamily="34" charset="0"/>
                <a:cs typeface="Arial" panose="020B0604020202020204" pitchFamily="34" charset="0"/>
              </a:rPr>
              <a:t>eIF3E::YFP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1596ECE-22B9-E446-FAF7-64484EE34673}"/>
              </a:ext>
            </a:extLst>
          </p:cNvPr>
          <p:cNvSpPr txBox="1"/>
          <p:nvPr/>
        </p:nvSpPr>
        <p:spPr>
          <a:xfrm>
            <a:off x="486438" y="2979291"/>
            <a:ext cx="2515432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Z" sz="2400" b="1" dirty="0">
                <a:latin typeface="Arial" panose="020B0604020202020204" pitchFamily="34" charset="0"/>
                <a:cs typeface="Arial" panose="020B0604020202020204" pitchFamily="34" charset="0"/>
              </a:rPr>
              <a:t>eIF3E</a:t>
            </a:r>
            <a:r>
              <a:rPr lang="en-CZ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T417</a:t>
            </a:r>
            <a:r>
              <a:rPr lang="en-CZ" sz="2400" b="1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CZ" sz="2400" b="1" dirty="0">
                <a:latin typeface="Arial" panose="020B0604020202020204" pitchFamily="34" charset="0"/>
                <a:cs typeface="Arial" panose="020B0604020202020204" pitchFamily="34" charset="0"/>
              </a:rPr>
              <a:t>::YFP</a:t>
            </a:r>
            <a:endParaRPr lang="en-CZ" sz="24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5281DDD-C9D0-70C2-3C41-642D274FBA5B}"/>
              </a:ext>
            </a:extLst>
          </p:cNvPr>
          <p:cNvSpPr txBox="1"/>
          <p:nvPr/>
        </p:nvSpPr>
        <p:spPr>
          <a:xfrm>
            <a:off x="486438" y="4230376"/>
            <a:ext cx="2528256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Z" sz="2400" b="1" dirty="0">
                <a:latin typeface="Arial" panose="020B0604020202020204" pitchFamily="34" charset="0"/>
                <a:cs typeface="Arial" panose="020B0604020202020204" pitchFamily="34" charset="0"/>
              </a:rPr>
              <a:t>eIF3E</a:t>
            </a:r>
            <a:r>
              <a:rPr lang="en-CZ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S421</a:t>
            </a:r>
            <a:r>
              <a:rPr lang="en-CZ" sz="2400" b="1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CZ" sz="2400" b="1" dirty="0">
                <a:latin typeface="Arial" panose="020B0604020202020204" pitchFamily="34" charset="0"/>
                <a:cs typeface="Arial" panose="020B0604020202020204" pitchFamily="34" charset="0"/>
              </a:rPr>
              <a:t>::YFP</a:t>
            </a:r>
            <a:endParaRPr lang="en-CZ" sz="24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2295856-4AF8-957B-BB37-72824C18E473}"/>
              </a:ext>
            </a:extLst>
          </p:cNvPr>
          <p:cNvSpPr txBox="1"/>
          <p:nvPr/>
        </p:nvSpPr>
        <p:spPr>
          <a:xfrm>
            <a:off x="1020320" y="276701"/>
            <a:ext cx="851547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Z" sz="3200" b="1" dirty="0">
                <a:latin typeface="Arial" panose="020B0604020202020204" pitchFamily="34" charset="0"/>
                <a:cs typeface="Arial" panose="020B0604020202020204" pitchFamily="34" charset="0"/>
              </a:rPr>
              <a:t>Supplementry video 2, supporting Figure 8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BA7A85B-7BC2-229E-884A-80D5156463A2}"/>
              </a:ext>
            </a:extLst>
          </p:cNvPr>
          <p:cNvSpPr txBox="1"/>
          <p:nvPr/>
        </p:nvSpPr>
        <p:spPr>
          <a:xfrm>
            <a:off x="6759629" y="1533268"/>
            <a:ext cx="494593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Z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video 2: Phosphodead eIF3E induces pollen tube and vegetative nuclear membrane morphological defects and loss in polarity.</a:t>
            </a:r>
          </a:p>
          <a:p>
            <a:pPr algn="just"/>
            <a:r>
              <a:rPr lang="en-CZ" sz="1200" dirty="0">
                <a:latin typeface="Arial" panose="020B0604020202020204" pitchFamily="34" charset="0"/>
                <a:cs typeface="Arial" panose="020B0604020202020204" pitchFamily="34" charset="0"/>
              </a:rPr>
              <a:t>Time laps live cell imaging of tobacco pollen tubes expressing control proUBQ10:AteIF3E::YFP compared with </a:t>
            </a:r>
            <a:r>
              <a:rPr lang="en-CZ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oUBQ10:AteIF3E</a:t>
            </a:r>
            <a:r>
              <a:rPr lang="en-CZ" sz="1200" kern="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417</a:t>
            </a:r>
            <a:r>
              <a:rPr lang="en-CZ" sz="1200" kern="0" baseline="300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CZ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:YFP and proUBQ10:AteIF3E</a:t>
            </a:r>
            <a:r>
              <a:rPr lang="en-CZ" sz="1200" kern="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</a:t>
            </a:r>
            <a:r>
              <a:rPr lang="en-CZ" sz="1200" kern="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421</a:t>
            </a:r>
            <a:r>
              <a:rPr lang="en-CZ" sz="1200" kern="0" baseline="300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CZ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:</a:t>
            </a:r>
            <a:r>
              <a:rPr lang="en-CZ" sz="1200" kern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YFP. </a:t>
            </a:r>
            <a:r>
              <a:rPr lang="en-CZ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 slow down in cytoplasmic streaming is apparent in both phosphodead mutations which also influence uncharcateristic vegetative nucllear mobility. </a:t>
            </a:r>
            <a:r>
              <a:rPr lang="en-CZ" sz="1200" dirty="0">
                <a:latin typeface="Arial" panose="020B0604020202020204" pitchFamily="34" charset="0"/>
                <a:cs typeface="Arial" panose="020B0604020202020204" pitchFamily="34" charset="0"/>
              </a:rPr>
              <a:t>Images were captured for 1min and processed using imageJ software.</a:t>
            </a:r>
          </a:p>
        </p:txBody>
      </p:sp>
    </p:spTree>
    <p:extLst>
      <p:ext uri="{BB962C8B-B14F-4D97-AF65-F5344CB8AC3E}">
        <p14:creationId xmlns:p14="http://schemas.microsoft.com/office/powerpoint/2010/main" val="161552554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33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1033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1033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" fill="hold">
                            <p:stCondLst>
                              <p:cond delay="2066"/>
                            </p:stCondLst>
                            <p:childTnLst>
                              <p:par>
                                <p:cTn id="11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1033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3" repeatCount="indefinite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19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20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1" fill="hold">
                      <p:stCondLst>
                        <p:cond delay="0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4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25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26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7" fill="hold">
                      <p:stCondLst>
                        <p:cond delay="0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0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41</TotalTime>
  <Words>97</Words>
  <Application>Microsoft Macintosh PowerPoint</Application>
  <PresentationFormat>Widescreen</PresentationFormat>
  <Paragraphs>6</Paragraphs>
  <Slides>1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nod Kumar</dc:creator>
  <cp:lastModifiedBy>Vinod Kumar</cp:lastModifiedBy>
  <cp:revision>27</cp:revision>
  <dcterms:created xsi:type="dcterms:W3CDTF">2025-06-11T08:40:26Z</dcterms:created>
  <dcterms:modified xsi:type="dcterms:W3CDTF">2025-09-08T07:34:32Z</dcterms:modified>
</cp:coreProperties>
</file>